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93" r:id="rId2"/>
  </p:sldIdLst>
  <p:sldSz cx="6492875" cy="6218238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37" userDrawn="1">
          <p15:clr>
            <a:srgbClr val="A4A3A4"/>
          </p15:clr>
        </p15:guide>
        <p15:guide id="3" orient="horz" pos="375" userDrawn="1">
          <p15:clr>
            <a:srgbClr val="A4A3A4"/>
          </p15:clr>
        </p15:guide>
        <p15:guide id="4" pos="1349" userDrawn="1">
          <p15:clr>
            <a:srgbClr val="A4A3A4"/>
          </p15:clr>
        </p15:guide>
        <p15:guide id="5" orient="horz" pos="20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udhary, Ritu" initials="CR" lastIdx="1" clrIdx="0">
    <p:extLst>
      <p:ext uri="{19B8F6BF-5375-455C-9EA6-DF929625EA0E}">
        <p15:presenceInfo xmlns:p15="http://schemas.microsoft.com/office/powerpoint/2012/main" userId="S::Ritu.Chaudhary@moffitt.org::e213b328-12f3-42f9-9afb-2fdf354946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D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32" autoAdjust="0"/>
    <p:restoredTop sz="90099" autoAdjust="0"/>
  </p:normalViewPr>
  <p:slideViewPr>
    <p:cSldViewPr snapToGrid="0">
      <p:cViewPr varScale="1">
        <p:scale>
          <a:sx n="160" d="100"/>
          <a:sy n="160" d="100"/>
        </p:scale>
        <p:origin x="3736" y="84"/>
      </p:cViewPr>
      <p:guideLst>
        <p:guide pos="3437"/>
        <p:guide orient="horz" pos="375"/>
        <p:guide pos="1349"/>
        <p:guide orient="horz" pos="203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3D79D2C-534C-49B8-BF89-98F21FED85F5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1663" y="1163638"/>
            <a:ext cx="32797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FBF2B51-D0C1-4CC3-B696-54FB44FD7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84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76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52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628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504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79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255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131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3007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BF2B51-D0C1-4CC3-B696-54FB44FD7B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2516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017661"/>
            <a:ext cx="5518944" cy="2164868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3266015"/>
            <a:ext cx="4869656" cy="1501301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5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331064"/>
            <a:ext cx="1400026" cy="5269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331064"/>
            <a:ext cx="4118918" cy="5269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61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1550243"/>
            <a:ext cx="5600105" cy="2586614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4161327"/>
            <a:ext cx="5600105" cy="136023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08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331065"/>
            <a:ext cx="5600105" cy="12019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1524332"/>
            <a:ext cx="2746790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2271384"/>
            <a:ext cx="2746790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1524332"/>
            <a:ext cx="2760318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2271384"/>
            <a:ext cx="2760318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3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895313"/>
            <a:ext cx="3287018" cy="4418979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8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895313"/>
            <a:ext cx="3287018" cy="4418979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331065"/>
            <a:ext cx="5600105" cy="12019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1655318"/>
            <a:ext cx="5600105" cy="39454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5763387"/>
            <a:ext cx="2191345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25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91AC0C56-4F08-4CBF-B055-DE5369ABCB8C}"/>
              </a:ext>
            </a:extLst>
          </p:cNvPr>
          <p:cNvGrpSpPr/>
          <p:nvPr/>
        </p:nvGrpSpPr>
        <p:grpSpPr>
          <a:xfrm>
            <a:off x="446426" y="470911"/>
            <a:ext cx="4358557" cy="3742014"/>
            <a:chOff x="319517" y="-1952918"/>
            <a:chExt cx="7155900" cy="6840281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DA611D1-6D0C-4952-B649-EA034747F746}"/>
                </a:ext>
              </a:extLst>
            </p:cNvPr>
            <p:cNvSpPr txBox="1"/>
            <p:nvPr/>
          </p:nvSpPr>
          <p:spPr>
            <a:xfrm>
              <a:off x="2712260" y="4709310"/>
              <a:ext cx="2746020" cy="178053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XTURE</a:t>
              </a:r>
            </a:p>
          </p:txBody>
        </p:sp>
        <p:pic>
          <p:nvPicPr>
            <p:cNvPr id="6" name="Picture 5" descr="A picture containing application&#10;&#10;Description automatically generated">
              <a:extLst>
                <a:ext uri="{FF2B5EF4-FFF2-40B4-BE49-F238E27FC236}">
                  <a16:creationId xmlns:a16="http://schemas.microsoft.com/office/drawing/2014/main" id="{3BE6BAF2-BBF0-4C82-8039-B52BA60294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306"/>
            <a:stretch/>
          </p:blipFill>
          <p:spPr>
            <a:xfrm>
              <a:off x="319517" y="-1952918"/>
              <a:ext cx="6802251" cy="663921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B1C829A-4BF9-4529-A06B-7EF67DF98CDC}"/>
                </a:ext>
              </a:extLst>
            </p:cNvPr>
            <p:cNvSpPr txBox="1"/>
            <p:nvPr/>
          </p:nvSpPr>
          <p:spPr>
            <a:xfrm rot="5400000">
              <a:off x="6181752" y="3392638"/>
              <a:ext cx="2248777" cy="338552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mmune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Gene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FDCE58C-9FB6-455A-8749-9447B748A793}"/>
                </a:ext>
              </a:extLst>
            </p:cNvPr>
            <p:cNvSpPr txBox="1"/>
            <p:nvPr/>
          </p:nvSpPr>
          <p:spPr>
            <a:xfrm rot="5400000">
              <a:off x="6165505" y="1127612"/>
              <a:ext cx="2281271" cy="338552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Gene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E577892-E6BD-4173-B5F7-12B58F0F5B89}"/>
                </a:ext>
              </a:extLst>
            </p:cNvPr>
            <p:cNvSpPr txBox="1"/>
            <p:nvPr/>
          </p:nvSpPr>
          <p:spPr>
            <a:xfrm>
              <a:off x="982102" y="4718324"/>
              <a:ext cx="1738886" cy="167020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6B95CA8-1885-4C3D-B08A-E79D17AAE051}"/>
                </a:ext>
              </a:extLst>
            </p:cNvPr>
            <p:cNvSpPr txBox="1"/>
            <p:nvPr/>
          </p:nvSpPr>
          <p:spPr>
            <a:xfrm>
              <a:off x="5459003" y="4707290"/>
              <a:ext cx="1630586" cy="178053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MMUNE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7D0B1051-087B-4089-953B-04B8EC382117}"/>
              </a:ext>
            </a:extLst>
          </p:cNvPr>
          <p:cNvSpPr txBox="1"/>
          <p:nvPr/>
        </p:nvSpPr>
        <p:spPr>
          <a:xfrm>
            <a:off x="4964070" y="5403"/>
            <a:ext cx="16038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E13A116-4E46-42AE-9439-DBDB98A8E334}"/>
              </a:ext>
            </a:extLst>
          </p:cNvPr>
          <p:cNvSpPr txBox="1"/>
          <p:nvPr/>
        </p:nvSpPr>
        <p:spPr>
          <a:xfrm>
            <a:off x="1816742" y="217577"/>
            <a:ext cx="16179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CC#18754 (n=48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C232793-7BE4-40F4-87CA-305A08F86FEC}"/>
              </a:ext>
            </a:extLst>
          </p:cNvPr>
          <p:cNvSpPr txBox="1"/>
          <p:nvPr/>
        </p:nvSpPr>
        <p:spPr>
          <a:xfrm>
            <a:off x="202223" y="4325817"/>
            <a:ext cx="62166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3: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eatmap of molecular subgroups in MCC18754 (n=48). RNA expression data was z-normalized, each row represents a single gene in the Hypoxia-Immune signature gene list, each column represents a patient sample. Samples were reordered according to its molecular subgroup: Immune (blue), Mixture (black) and Hypoxia (red)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66618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715</TotalTime>
  <Words>85</Words>
  <Application>Microsoft Office PowerPoint</Application>
  <PresentationFormat>Custom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udhary, Ritu</dc:creator>
  <cp:lastModifiedBy>Chung, Christine H</cp:lastModifiedBy>
  <cp:revision>383</cp:revision>
  <cp:lastPrinted>2022-01-03T15:25:01Z</cp:lastPrinted>
  <dcterms:created xsi:type="dcterms:W3CDTF">2021-01-11T21:01:01Z</dcterms:created>
  <dcterms:modified xsi:type="dcterms:W3CDTF">2023-04-30T13:08:00Z</dcterms:modified>
</cp:coreProperties>
</file>